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68" r:id="rId3"/>
    <p:sldId id="269" r:id="rId4"/>
    <p:sldId id="266" r:id="rId5"/>
    <p:sldId id="270" r:id="rId6"/>
    <p:sldId id="267" r:id="rId7"/>
    <p:sldId id="257" r:id="rId8"/>
    <p:sldId id="271" r:id="rId9"/>
    <p:sldId id="258" r:id="rId10"/>
    <p:sldId id="260" r:id="rId11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56" autoAdjust="0"/>
    <p:restoredTop sz="94660"/>
  </p:normalViewPr>
  <p:slideViewPr>
    <p:cSldViewPr snapToGrid="0">
      <p:cViewPr varScale="1">
        <p:scale>
          <a:sx n="82" d="100"/>
          <a:sy n="82" d="100"/>
        </p:scale>
        <p:origin x="307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83D84-D36B-46B1-AAEA-373E3B3A988D}" type="datetimeFigureOut">
              <a:rPr lang="en-US" smtClean="0"/>
              <a:t>8/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01BD9-9FFA-47E9-B3C1-C55E8E886E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83D84-D36B-46B1-AAEA-373E3B3A988D}" type="datetimeFigureOut">
              <a:rPr lang="en-US" smtClean="0"/>
              <a:t>8/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01BD9-9FFA-47E9-B3C1-C55E8E886E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83D84-D36B-46B1-AAEA-373E3B3A988D}" type="datetimeFigureOut">
              <a:rPr lang="en-US" smtClean="0"/>
              <a:t>8/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01BD9-9FFA-47E9-B3C1-C55E8E886E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83D84-D36B-46B1-AAEA-373E3B3A988D}" type="datetimeFigureOut">
              <a:rPr lang="en-US" smtClean="0"/>
              <a:t>8/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01BD9-9FFA-47E9-B3C1-C55E8E886E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83D84-D36B-46B1-AAEA-373E3B3A988D}" type="datetimeFigureOut">
              <a:rPr lang="en-US" smtClean="0"/>
              <a:t>8/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01BD9-9FFA-47E9-B3C1-C55E8E886E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83D84-D36B-46B1-AAEA-373E3B3A988D}" type="datetimeFigureOut">
              <a:rPr lang="en-US" smtClean="0"/>
              <a:t>8/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01BD9-9FFA-47E9-B3C1-C55E8E886E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83D84-D36B-46B1-AAEA-373E3B3A988D}" type="datetimeFigureOut">
              <a:rPr lang="en-US" smtClean="0"/>
              <a:t>8/7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01BD9-9FFA-47E9-B3C1-C55E8E886E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83D84-D36B-46B1-AAEA-373E3B3A988D}" type="datetimeFigureOut">
              <a:rPr lang="en-US" smtClean="0"/>
              <a:t>8/7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01BD9-9FFA-47E9-B3C1-C55E8E886E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83D84-D36B-46B1-AAEA-373E3B3A988D}" type="datetimeFigureOut">
              <a:rPr lang="en-US" smtClean="0"/>
              <a:t>8/7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01BD9-9FFA-47E9-B3C1-C55E8E886E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83D84-D36B-46B1-AAEA-373E3B3A988D}" type="datetimeFigureOut">
              <a:rPr lang="en-US" smtClean="0"/>
              <a:t>8/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01BD9-9FFA-47E9-B3C1-C55E8E886E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A83D84-D36B-46B1-AAEA-373E3B3A988D}" type="datetimeFigureOut">
              <a:rPr lang="en-US" smtClean="0"/>
              <a:t>8/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01BD9-9FFA-47E9-B3C1-C55E8E886E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A83D84-D36B-46B1-AAEA-373E3B3A988D}" type="datetimeFigureOut">
              <a:rPr lang="en-US" smtClean="0"/>
              <a:t>8/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01BD9-9FFA-47E9-B3C1-C55E8E886E7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9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0810" y="374650"/>
            <a:ext cx="4218940" cy="657987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81455" y="6940787"/>
            <a:ext cx="621195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1. C-to-T base editing efficiencies and editing windows by BE3 and CGBEs in rice protoplasts. </a:t>
            </a:r>
            <a:r>
              <a:rPr lang="en-US" sz="1400" dirty="0"/>
              <a:t>(A) NGS assessment of BE3 and three CGBEs at editing for C-to-T editing at two target sites in rice protoplasts. (B) C-to-T editing windows at the OsALS-sgRNA32 site by four base editors. (C) C-to-T editing windows at the OsCGRS55</a:t>
            </a:r>
            <a:r>
              <a:rPr lang="en-US" sz="1400" dirty="0">
                <a:sym typeface="+mn-ea"/>
              </a:rPr>
              <a:t>-sgRNA</a:t>
            </a:r>
            <a:r>
              <a:rPr lang="en-US" sz="1400" dirty="0"/>
              <a:t> site by four base editors. The error bars represent standard errors of three biological replicates. </a:t>
            </a:r>
            <a:endParaRPr lang="en-US" sz="1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945583" y="272940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945970" y="30569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45583" y="485741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C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3"/>
          <p:cNvSpPr txBox="1"/>
          <p:nvPr/>
        </p:nvSpPr>
        <p:spPr>
          <a:xfrm>
            <a:off x="603872" y="853252"/>
            <a:ext cx="5662816" cy="15696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OsALS-sgRNA32 target:     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tcacgggc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ggtcccccgccgcatga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g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ccgacgcc</a:t>
            </a:r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pLR3741-10:</a:t>
            </a:r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              Allele 1: 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tcacgggc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ggtc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ttttt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cgcatga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g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ccgacgcc</a:t>
            </a:r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C-to-T</a:t>
            </a:r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              Allele 2: 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tcacgggc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ggtc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ttg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ccgcatga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g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ccgacgcc</a:t>
            </a:r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C-to-T &amp; C-to-G</a:t>
            </a:r>
            <a:endParaRPr lang="zh-CN" altLang="en-US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pLR3741-11:</a:t>
            </a:r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              Allele 1: 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tcacgggc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gg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ttgtt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gccgcatga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g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ccgacgcc</a:t>
            </a:r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C-to-T &amp; C-to-G</a:t>
            </a:r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              Allele 2: 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tcacgggc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gg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ttg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cgccgcatga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g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ccgacgcc</a:t>
            </a:r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C-to-T &amp; C-to-G</a:t>
            </a: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pLR3741-12:</a:t>
            </a:r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              Allele 1: 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tcacgggc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gg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ttttt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gccgcatga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g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ccgacgcc</a:t>
            </a:r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C-to-T</a:t>
            </a:r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              Allele 2: 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tcacgggc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gg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ttgt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ccgcatga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g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ccgacgcc</a:t>
            </a:r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C-to-T &amp; C-to-G</a:t>
            </a:r>
            <a:endParaRPr lang="zh-CN" altLang="en-US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  <a:sym typeface="+mn-ea"/>
            </a:endParaRPr>
          </a:p>
        </p:txBody>
      </p:sp>
      <p:sp>
        <p:nvSpPr>
          <p:cNvPr id="3" name="文本框 3"/>
          <p:cNvSpPr txBox="1"/>
          <p:nvPr/>
        </p:nvSpPr>
        <p:spPr>
          <a:xfrm>
            <a:off x="603873" y="3892831"/>
            <a:ext cx="5870079" cy="707886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OsALS-sgRNA32 target:     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tcacgggc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ggtcccccgccgcatga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g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ccgacgcc</a:t>
            </a:r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pLR3750-22:</a:t>
            </a:r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              Allele 1: 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tcacgggc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gg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ttt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cgccgcatga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g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ccgacgcc</a:t>
            </a:r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C-to-T</a:t>
            </a:r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              Allele 2: 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tcacgggc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gg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tg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ccgccgcatga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g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ccgacgcc</a:t>
            </a:r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C-to-T &amp; C-to-G</a:t>
            </a:r>
          </a:p>
        </p:txBody>
      </p:sp>
      <p:sp>
        <p:nvSpPr>
          <p:cNvPr id="4" name="文本框 4"/>
          <p:cNvSpPr txBox="1"/>
          <p:nvPr/>
        </p:nvSpPr>
        <p:spPr>
          <a:xfrm>
            <a:off x="603873" y="2751665"/>
            <a:ext cx="51751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</a:rPr>
              <a:t>OsALS-sgRNA32 target:     catcacgggc</a:t>
            </a:r>
            <a:r>
              <a:rPr lang="en-US" altLang="zh-CN" sz="800" dirty="0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</a:rPr>
              <a:t>caggtcccccgccgcatgat</a:t>
            </a:r>
            <a:r>
              <a:rPr lang="en-US" altLang="zh-CN" sz="800" dirty="0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</a:rPr>
              <a:t>cgg</a:t>
            </a:r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</a:rPr>
              <a:t>caccgacgcc</a:t>
            </a:r>
          </a:p>
          <a:p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pLR3747-8:</a:t>
            </a:r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              Allele 1: 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tcacgggc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gg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g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cc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g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gccgcatga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g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ccgacgcc</a:t>
            </a:r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C-to-G</a:t>
            </a:r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</a:endParaRPr>
          </a:p>
          <a:p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              Allele 2: 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tcacgggc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gg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t</a:t>
            </a:r>
            <a:r>
              <a:rPr lang="en-US" altLang="zh-CN" sz="800" dirty="0" err="1">
                <a:solidFill>
                  <a:srgbClr val="0000FF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cccgccgcatgat</a:t>
            </a:r>
            <a:r>
              <a:rPr lang="en-US" altLang="zh-CN" sz="800" dirty="0" err="1">
                <a:solidFill>
                  <a:srgbClr val="FF0000"/>
                </a:solidFill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gg</a:t>
            </a:r>
            <a:r>
              <a:rPr lang="en-US" altLang="zh-CN" sz="800" dirty="0" err="1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caccgacgcc</a:t>
            </a:r>
            <a:r>
              <a:rPr lang="en-US" altLang="zh-CN" sz="800" dirty="0">
                <a:latin typeface="Courier New" panose="02070409020205090404" pitchFamily="49" charset="0"/>
                <a:cs typeface="Courier New" panose="02070409020205090404" pitchFamily="49" charset="0"/>
                <a:sym typeface="+mn-ea"/>
              </a:rPr>
              <a:t>  C-to-T</a:t>
            </a:r>
          </a:p>
          <a:p>
            <a:endParaRPr lang="en-US" altLang="zh-CN" sz="800" dirty="0">
              <a:latin typeface="Courier New" panose="02070409020205090404" pitchFamily="49" charset="0"/>
              <a:cs typeface="Courier New" panose="02070409020205090404" pitchFamily="49" charset="0"/>
              <a:sym typeface="+mn-ea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12589" y="5075667"/>
            <a:ext cx="637912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10. C-to-G base editing in T0 rice lines. </a:t>
            </a:r>
            <a:r>
              <a:rPr lang="en-US" sz="1400" dirty="0"/>
              <a:t>(A) Three pLR3741 T0 lines contain alleles with simultaneous C-to-T and C-to-G editing. (B) One pLR3747 T0 line contains biallelic C-to-G and C-to-T editing. (C) One pLR3750 T0 line contains an allele with simultaneous C-to-T and C-to-g editing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71343" y="258238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71730" y="69081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71343" y="372355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C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55363" y="260526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55750" y="22043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55363" y="486969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69263" y="7055640"/>
            <a:ext cx="621195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2. C-to-A base editing efficiencies and editing windows by BE3 and CGBEs in rice protoplasts. </a:t>
            </a:r>
            <a:r>
              <a:rPr lang="en-US" sz="1400" dirty="0"/>
              <a:t>(A) NGS assessment of BE3 and three CGBEs at editing for C-to-A editing at two target sites in rice protoplasts. (B) C-to-A editing windows at the OsALS-sgRNA32 site by four base editors. (C) C-to-A editing windows at the </a:t>
            </a:r>
            <a:r>
              <a:rPr lang="en-US" sz="1400" dirty="0">
                <a:sym typeface="+mn-ea"/>
              </a:rPr>
              <a:t>OsCGRS55-sgRNA</a:t>
            </a:r>
            <a:r>
              <a:rPr lang="en-US" sz="1400" dirty="0"/>
              <a:t> site by four base editors. The error bars represent standard errors of three biological replicates. </a:t>
            </a:r>
            <a:endParaRPr lang="en-US" sz="1400" b="1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1740" y="322580"/>
            <a:ext cx="4463415" cy="657987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30223" y="5019576"/>
            <a:ext cx="621195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3. NGS assessment of indel frequencies at the two target sites by BE3 and CGBEs in rice protoplasts. </a:t>
            </a:r>
            <a:r>
              <a:rPr lang="en-US" sz="1400" dirty="0"/>
              <a:t>The error bars represent standard errors of three biological replicates. </a:t>
            </a:r>
            <a:endParaRPr lang="en-US" sz="1400" b="1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7400" y="1284605"/>
            <a:ext cx="5367020" cy="3405505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592296" y="433518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92683" y="109672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05838" y="6544817"/>
            <a:ext cx="621195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4. C-to-T base editing efficiencies and editing windows by BE3 and CGBEs in tomato protoplasts. </a:t>
            </a:r>
            <a:r>
              <a:rPr lang="en-US" sz="1400" dirty="0"/>
              <a:t>(A) NGS assessment of BE3 and three CGBEs for C-to-T editing at four target sites in tomato protoplasts. (B) C-to-T editing windows at the SAGo7-gR3 site by four base editors. (C) C-to-T editing windows at the SAgo7-gR4 site by four base editors. The error bars represent standard errors of three biological replicates. </a:t>
            </a:r>
            <a:endParaRPr lang="en-US" sz="1400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61BC7302-7F69-41E7-B841-6D0A77DDAD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4438" y="990514"/>
            <a:ext cx="4773168" cy="319125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068DC23-3229-4F59-B67B-2FF635E704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7829" y="4428261"/>
            <a:ext cx="6120000" cy="1725687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87550" y="5386577"/>
            <a:ext cx="621195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5. Indel frequencies by BE3 and CGBEs in tomato protoplasts. </a:t>
            </a:r>
            <a:r>
              <a:rPr lang="en-US" sz="1400" dirty="0"/>
              <a:t>NGS assessment of indel frequencies at four target sites in tomato protoplasts. The error bars represent standard errors of three biological replicates. </a:t>
            </a:r>
            <a:endParaRPr lang="en-US" sz="1400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817B0834-0C23-4870-9E25-C1E120498F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0130" y="1964469"/>
            <a:ext cx="4777740" cy="294894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54660" y="5395651"/>
            <a:ext cx="621195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6. C-to-A base editing efficiencies by BE3 and CGBEs in tomato protoplasts. </a:t>
            </a:r>
            <a:r>
              <a:rPr lang="en-US" sz="1400" dirty="0"/>
              <a:t>NGS assessment of BE3 and three CGBEs for C-to-A editing at four target sites in tomato protoplasts. The error bars represent standard errors of three biological replicates. </a:t>
            </a:r>
            <a:endParaRPr lang="en-US" sz="1400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89D377B-9E35-42B1-B52C-673A8D456C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1080" y="2077278"/>
            <a:ext cx="4815840" cy="320040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294753" y="6821813"/>
            <a:ext cx="637912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7. C-to-T base editing windows by three SpRY-based CGBEs in rice protoplasts. </a:t>
            </a:r>
            <a:r>
              <a:rPr lang="en-US" sz="1400" dirty="0"/>
              <a:t>(A) NGS assessment of three SpRY-based CGBEs for C-to-T editing at nine target sites in rice protoplasts. (B) C-to-T base editing windows by three SpRY-based CGBEs at 9 target sites in rice protoplasts. The error bars represent standard errors of three biological replicates.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98191" y="281403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28770" y="31235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7025" y="376555"/>
            <a:ext cx="3867785" cy="239395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740" y="2997200"/>
            <a:ext cx="6322060" cy="3440430"/>
          </a:xfrm>
          <a:prstGeom prst="rect">
            <a:avLst/>
          </a:prstGeom>
        </p:spPr>
      </p:pic>
      <p:pic>
        <p:nvPicPr>
          <p:cNvPr id="6" name="图片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10100" y="374015"/>
            <a:ext cx="786130" cy="65278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630" y="1387475"/>
            <a:ext cx="5252085" cy="3429000"/>
          </a:xfrm>
          <a:prstGeom prst="rect">
            <a:avLst/>
          </a:prstGeom>
        </p:spPr>
      </p:pic>
      <p:pic>
        <p:nvPicPr>
          <p:cNvPr id="5" name="图片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21530" y="1365250"/>
            <a:ext cx="1137920" cy="90106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87550" y="5386577"/>
            <a:ext cx="621195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8. Indel frequencies three SpRY-based CGBEs in rice protoplasts. </a:t>
            </a:r>
            <a:r>
              <a:rPr lang="en-US" sz="1400" dirty="0"/>
              <a:t>NGS assessment of indel frequencies at nine target sites in rice protoplasts. The error bars represent standard errors of three biological replicates. </a:t>
            </a:r>
            <a:endParaRPr lang="en-US" sz="1400" b="1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198191" y="30456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28770" y="42208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94753" y="6821813"/>
            <a:ext cx="637912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9. C-to-A base editing windows by three SpRY-based CGBEs in rice protoplasts. </a:t>
            </a:r>
            <a:r>
              <a:rPr lang="en-US" sz="1400" dirty="0"/>
              <a:t>(A) NGS assessment of three SpRY-based CGBEs for C-to-A editing at nine target sites in rice protoplasts. (B) C-to-A base editing windows by three SpRY-based CGBEs at 9 target sites in rice protoplasts. The error bars represent standard errors of three biological replicates.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7425" y="352425"/>
            <a:ext cx="3992245" cy="2457450"/>
          </a:xfrm>
          <a:prstGeom prst="rect">
            <a:avLst/>
          </a:prstGeom>
        </p:spPr>
      </p:pic>
      <p:pic>
        <p:nvPicPr>
          <p:cNvPr id="6" name="图片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37990" y="393700"/>
            <a:ext cx="780415" cy="61785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6240" y="3324225"/>
            <a:ext cx="6244590" cy="3306445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698</Words>
  <Application>Microsoft Macintosh PowerPoint</Application>
  <PresentationFormat>On-screen Show (4:3)</PresentationFormat>
  <Paragraphs>46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ping Qi</dc:creator>
  <cp:lastModifiedBy>Yiping Qi</cp:lastModifiedBy>
  <cp:revision>67</cp:revision>
  <dcterms:created xsi:type="dcterms:W3CDTF">2021-07-16T15:22:37Z</dcterms:created>
  <dcterms:modified xsi:type="dcterms:W3CDTF">2021-08-08T00:39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3.1.1.4956</vt:lpwstr>
  </property>
</Properties>
</file>